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10"/>
    <p:restoredTop sz="94694"/>
  </p:normalViewPr>
  <p:slideViewPr>
    <p:cSldViewPr snapToGrid="0">
      <p:cViewPr>
        <p:scale>
          <a:sx n="110" d="100"/>
          <a:sy n="110" d="100"/>
        </p:scale>
        <p:origin x="3048" y="-30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482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13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09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708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490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600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446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444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208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705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362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26B7A6-AF1C-794E-BCEF-5EA633E793BC}" type="datetimeFigureOut">
              <a:rPr lang="en-US" smtClean="0"/>
              <a:t>11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ED01F7-12A5-654A-8841-D08D0062E3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486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2BBD6B8-DBDD-C3AA-1CBA-CD5348685FB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1539" b="2222"/>
          <a:stretch/>
        </p:blipFill>
        <p:spPr>
          <a:xfrm>
            <a:off x="674369" y="880111"/>
            <a:ext cx="5509261" cy="1000366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9E04C19-A465-581F-B31A-CF502798E3DE}"/>
              </a:ext>
            </a:extLst>
          </p:cNvPr>
          <p:cNvSpPr txBox="1"/>
          <p:nvPr/>
        </p:nvSpPr>
        <p:spPr>
          <a:xfrm>
            <a:off x="536760" y="10988723"/>
            <a:ext cx="58983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lignment of IS5 at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bU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oe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equence 1) with wildtype IS5 (Sequence 2).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ched nucleotides between two sequences are marked by stars while unmatched ones are not marked. There is a 99.6% identity between the two IS elements.</a:t>
            </a:r>
          </a:p>
        </p:txBody>
      </p:sp>
    </p:spTree>
    <p:extLst>
      <p:ext uri="{BB962C8B-B14F-4D97-AF65-F5344CB8AC3E}">
        <p14:creationId xmlns:p14="http://schemas.microsoft.com/office/powerpoint/2010/main" val="3749200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49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ngge Zhang</dc:creator>
  <cp:lastModifiedBy>Huo, Jialu</cp:lastModifiedBy>
  <cp:revision>7</cp:revision>
  <dcterms:created xsi:type="dcterms:W3CDTF">2024-10-18T21:09:23Z</dcterms:created>
  <dcterms:modified xsi:type="dcterms:W3CDTF">2024-11-14T23:27:16Z</dcterms:modified>
</cp:coreProperties>
</file>